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62" r:id="rId2"/>
    <p:sldId id="264" r:id="rId3"/>
    <p:sldId id="258" r:id="rId4"/>
    <p:sldId id="261" r:id="rId5"/>
    <p:sldId id="256" r:id="rId6"/>
    <p:sldId id="257" r:id="rId7"/>
    <p:sldId id="263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906" y="-24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66CDA3-15FF-4AA0-AA90-5790B8EB9DE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1EA7E-7B21-4C38-946D-0F52D48E6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454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71EA7E-7B21-4C38-946D-0F52D48E656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676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58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034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373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51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424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711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89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49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169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758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514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BE94A-5A6A-440A-8826-9D46B1FAAAE3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631B0-DB4C-4438-A741-27D6186B6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252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2C0109B-014D-888A-CDC2-78387E5A63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8026" y="978063"/>
            <a:ext cx="2901948" cy="397493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0344675-371D-A997-3912-38497404F440}"/>
              </a:ext>
            </a:extLst>
          </p:cNvPr>
          <p:cNvSpPr txBox="1"/>
          <p:nvPr/>
        </p:nvSpPr>
        <p:spPr>
          <a:xfrm>
            <a:off x="180753" y="5597399"/>
            <a:ext cx="64964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1: </a:t>
            </a:r>
            <a:r>
              <a:rPr lang="en-US" sz="1400" dirty="0"/>
              <a:t>Schematic of the substrate used for the cleavage assay. Representative 12 % native PAGE gel to study the cleavage assay of SauUSI and </a:t>
            </a:r>
            <a:r>
              <a:rPr lang="en-US" sz="1400" dirty="0" err="1"/>
              <a:t>BstNI</a:t>
            </a:r>
            <a:r>
              <a:rPr lang="en-US" sz="1400" dirty="0"/>
              <a:t> (Type II </a:t>
            </a:r>
            <a:r>
              <a:rPr lang="en-US" sz="1400" dirty="0" err="1"/>
              <a:t>Rease</a:t>
            </a:r>
            <a:r>
              <a:rPr lang="en-US" sz="1400" dirty="0"/>
              <a:t>) on ssDNA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1C998C2-FA7A-4296-52F5-910B22DE94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9168" y="144671"/>
            <a:ext cx="1999661" cy="3779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5341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AB94D6A-6DAD-1A95-92CB-E4FC7D9BF7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8849" y="1754160"/>
            <a:ext cx="5220301" cy="288330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99894B8-0C88-B108-C0F2-C83B4559F493}"/>
              </a:ext>
            </a:extLst>
          </p:cNvPr>
          <p:cNvSpPr txBox="1"/>
          <p:nvPr/>
        </p:nvSpPr>
        <p:spPr>
          <a:xfrm>
            <a:off x="361506" y="5145058"/>
            <a:ext cx="62145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2 : </a:t>
            </a:r>
            <a:r>
              <a:rPr lang="en-US" sz="1400" dirty="0"/>
              <a:t>Representative 12 % Native gel to study the cleavage assay for 250 </a:t>
            </a:r>
            <a:r>
              <a:rPr lang="en-US" sz="1400" dirty="0" err="1"/>
              <a:t>nM</a:t>
            </a:r>
            <a:r>
              <a:rPr lang="en-US" sz="1400" dirty="0"/>
              <a:t> short ssDNA oligos: 25 bases, 30 bases, 40 bases and 50 bases, by 50 </a:t>
            </a:r>
            <a:r>
              <a:rPr lang="en-US" sz="1400" dirty="0" err="1"/>
              <a:t>nM</a:t>
            </a:r>
            <a:r>
              <a:rPr lang="en-US" sz="1400" dirty="0"/>
              <a:t> SauUSI.</a:t>
            </a:r>
          </a:p>
        </p:txBody>
      </p:sp>
    </p:spTree>
    <p:extLst>
      <p:ext uri="{BB962C8B-B14F-4D97-AF65-F5344CB8AC3E}">
        <p14:creationId xmlns:p14="http://schemas.microsoft.com/office/powerpoint/2010/main" val="40989065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BB57F09-6E59-5B3B-DF42-CA4A000A45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0769" y="1321076"/>
            <a:ext cx="4758162" cy="400093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8116812-C87A-0227-DA3C-6D6A933FAB9D}"/>
              </a:ext>
            </a:extLst>
          </p:cNvPr>
          <p:cNvSpPr txBox="1"/>
          <p:nvPr/>
        </p:nvSpPr>
        <p:spPr>
          <a:xfrm>
            <a:off x="180753" y="5597399"/>
            <a:ext cx="64964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3: </a:t>
            </a:r>
            <a:r>
              <a:rPr lang="en-US" sz="1400" dirty="0"/>
              <a:t>Schematic of the substrate used for the cleavage assay. Representative 1 % Agarose gel to study the cleavage assay for canonical dsDNA in two different buffer conditions (+/- Mg</a:t>
            </a:r>
            <a:r>
              <a:rPr lang="en-US" sz="1400" baseline="30000" dirty="0"/>
              <a:t>2+</a:t>
            </a:r>
            <a:r>
              <a:rPr lang="en-US" sz="1400" dirty="0"/>
              <a:t>) either in the presence or absence of ATP. The cleavage pattern was run in the presence of 1kB DNA mark ladder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9B4965-02F1-D619-5C02-FFCCBCD0F3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9651" y="411652"/>
            <a:ext cx="4249280" cy="634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2050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A5D67EC-C875-3391-3D1E-12649F9905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00" t="12065" r="16666"/>
          <a:stretch/>
        </p:blipFill>
        <p:spPr>
          <a:xfrm>
            <a:off x="1000125" y="2019300"/>
            <a:ext cx="4857750" cy="375348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B6A4405-71B2-0BBC-6F1E-679D7109407D}"/>
              </a:ext>
            </a:extLst>
          </p:cNvPr>
          <p:cNvSpPr txBox="1"/>
          <p:nvPr/>
        </p:nvSpPr>
        <p:spPr>
          <a:xfrm>
            <a:off x="361507" y="5677786"/>
            <a:ext cx="6138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4:</a:t>
            </a:r>
            <a:r>
              <a:rPr lang="en-US" sz="1400" dirty="0"/>
              <a:t> Percent cleavage of ssDNA (250 </a:t>
            </a:r>
            <a:r>
              <a:rPr lang="en-US" sz="1400" dirty="0" err="1"/>
              <a:t>nM</a:t>
            </a:r>
            <a:r>
              <a:rPr lang="en-US" sz="1400" dirty="0"/>
              <a:t>) as a function of concentration of SauUSI (10 </a:t>
            </a:r>
            <a:r>
              <a:rPr lang="en-US" sz="1400" dirty="0" err="1"/>
              <a:t>nM</a:t>
            </a:r>
            <a:r>
              <a:rPr lang="en-US" sz="1400" dirty="0"/>
              <a:t> – 200 </a:t>
            </a:r>
            <a:r>
              <a:rPr lang="en-US" sz="1400" dirty="0" err="1"/>
              <a:t>nM</a:t>
            </a:r>
            <a:r>
              <a:rPr lang="en-US" sz="1400" dirty="0"/>
              <a:t>) (n = 3). Representative gel in Figure 3b.</a:t>
            </a:r>
          </a:p>
        </p:txBody>
      </p:sp>
    </p:spTree>
    <p:extLst>
      <p:ext uri="{BB962C8B-B14F-4D97-AF65-F5344CB8AC3E}">
        <p14:creationId xmlns:p14="http://schemas.microsoft.com/office/powerpoint/2010/main" val="15246223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0561CF3-8A94-4D9C-6E3F-FE6DC84ACC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43585"/>
            <a:ext cx="6858000" cy="229339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E85EB82-43B2-C3F1-A292-8D13A21381A9}"/>
              </a:ext>
            </a:extLst>
          </p:cNvPr>
          <p:cNvSpPr txBox="1"/>
          <p:nvPr/>
        </p:nvSpPr>
        <p:spPr>
          <a:xfrm>
            <a:off x="361507" y="4657060"/>
            <a:ext cx="6130733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5: </a:t>
            </a:r>
            <a:r>
              <a:rPr lang="en-US" sz="1400" dirty="0"/>
              <a:t>Cartoon representing the difference between Exonucleases and Endonucleases in terms of their cleavage on DNA. Enzymes are represented as Red </a:t>
            </a:r>
            <a:r>
              <a:rPr lang="en-US" sz="1400" dirty="0" err="1"/>
              <a:t>pacmans</a:t>
            </a:r>
            <a:r>
              <a:rPr lang="en-US" sz="1400" dirty="0"/>
              <a:t> and nucleic acid is represented as green lines. </a:t>
            </a:r>
            <a:r>
              <a:rPr lang="en-US" sz="1400" dirty="0" err="1"/>
              <a:t>RecJ</a:t>
            </a:r>
            <a:r>
              <a:rPr lang="en-US" sz="1400" baseline="-25000" dirty="0" err="1"/>
              <a:t>f</a:t>
            </a:r>
            <a:r>
              <a:rPr lang="en-US" sz="1400" dirty="0"/>
              <a:t> catalyzes the cleavage of deoxy-nucleotide monophosphates with a 5’ polarity specificity on ssDNA. On the other hand, Exonuclease I from </a:t>
            </a:r>
            <a:r>
              <a:rPr lang="en-US" sz="1400" i="1" dirty="0"/>
              <a:t>E.coli</a:t>
            </a:r>
            <a:r>
              <a:rPr lang="en-US" sz="1400" dirty="0"/>
              <a:t> catalyzes the removal of deoxy-nucleotide monophosphates with a 3’ polarity specificity on ssDNA. Mung bean nuclease is a ssDNA endonuclease as it has the ability to cleave the single-stranded region of a hairpin DNA. Mung bean nuclease cleaves ssDNA/</a:t>
            </a:r>
            <a:r>
              <a:rPr lang="en-US" sz="1400" dirty="0" err="1"/>
              <a:t>ssRNA</a:t>
            </a:r>
            <a:r>
              <a:rPr lang="en-US" sz="1400" dirty="0"/>
              <a:t> efficiently eventually leading to deoxy-nucleotide/ribonucleotide monophosphates (without a polarity preference for the substrate)</a:t>
            </a:r>
            <a:endParaRPr 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39427278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B2077AE-8841-0D0B-236F-393B6C2824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4000" y="1192248"/>
            <a:ext cx="2089999" cy="356869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CD94596-6461-D50C-F49D-E4C9FE288C55}"/>
              </a:ext>
            </a:extLst>
          </p:cNvPr>
          <p:cNvSpPr txBox="1"/>
          <p:nvPr/>
        </p:nvSpPr>
        <p:spPr>
          <a:xfrm>
            <a:off x="361506" y="5145058"/>
            <a:ext cx="62145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6: </a:t>
            </a:r>
            <a:r>
              <a:rPr lang="en-US" sz="1400" dirty="0"/>
              <a:t>Schematic of the substrate used for the cleavage assay. Representative 12 % Native gel to study the cleavage assay for nicked dsDNA in the presence or absence of ATP. The cleavage pattern was run in the presence of ultra low-range DNA ladder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664D4D9-E889-A5EF-C9BB-2963C7131C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7360" y="0"/>
            <a:ext cx="2523963" cy="1133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0877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84B0B8F-4F9E-E02D-61B8-CB499ACFD81A}"/>
              </a:ext>
            </a:extLst>
          </p:cNvPr>
          <p:cNvSpPr txBox="1"/>
          <p:nvPr/>
        </p:nvSpPr>
        <p:spPr>
          <a:xfrm>
            <a:off x="359821" y="5981948"/>
            <a:ext cx="6138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7:</a:t>
            </a:r>
            <a:r>
              <a:rPr lang="en-US" sz="1400" dirty="0"/>
              <a:t> Distance between the sulfate ions is the SauUSI crystal structure. The total distance end - to – end was calculated to be ~25 Å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5E33D18-3460-8028-FEEA-70D1DB326E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95" t="6607" r="24237" b="14898"/>
          <a:stretch/>
        </p:blipFill>
        <p:spPr>
          <a:xfrm>
            <a:off x="1715566" y="3001107"/>
            <a:ext cx="3426864" cy="2683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0593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5</TotalTime>
  <Words>374</Words>
  <Application>Microsoft Office PowerPoint</Application>
  <PresentationFormat>A4 Paper (210x297 mm)</PresentationFormat>
  <Paragraphs>8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ayak Sadasivam</dc:creator>
  <cp:lastModifiedBy>Vinayak Sadasivam</cp:lastModifiedBy>
  <cp:revision>20</cp:revision>
  <dcterms:created xsi:type="dcterms:W3CDTF">2022-07-20T09:07:39Z</dcterms:created>
  <dcterms:modified xsi:type="dcterms:W3CDTF">2022-08-23T10:52:50Z</dcterms:modified>
</cp:coreProperties>
</file>